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373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>
        <p:scale>
          <a:sx n="80" d="100"/>
          <a:sy n="80" d="100"/>
        </p:scale>
        <p:origin x="-3876" y="-6"/>
      </p:cViewPr>
      <p:guideLst>
        <p:guide orient="horz" pos="4061"/>
        <p:guide pos="19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2391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5214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28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1517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9466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255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9234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6724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4841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102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8593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6306B-4A62-4EC2-9147-CC964D609D79}" type="datetimeFigureOut">
              <a:rPr lang="en-GB" smtClean="0"/>
              <a:t>19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13A6D-8B13-4B43-9F0D-FC2606EBC0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136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png"/><Relationship Id="rId7" Type="http://schemas.openxmlformats.org/officeDocument/2006/relationships/image" Target="../media/image12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722540" y="377718"/>
            <a:ext cx="5436927" cy="8930787"/>
            <a:chOff x="722540" y="377718"/>
            <a:chExt cx="5436927" cy="8930787"/>
          </a:xfrm>
        </p:grpSpPr>
        <p:grpSp>
          <p:nvGrpSpPr>
            <p:cNvPr id="102" name="Group 101"/>
            <p:cNvGrpSpPr/>
            <p:nvPr/>
          </p:nvGrpSpPr>
          <p:grpSpPr>
            <a:xfrm>
              <a:off x="722540" y="496659"/>
              <a:ext cx="2936701" cy="1635452"/>
              <a:chOff x="3163655" y="670523"/>
              <a:chExt cx="2936701" cy="1635452"/>
            </a:xfrm>
          </p:grpSpPr>
          <p:grpSp>
            <p:nvGrpSpPr>
              <p:cNvPr id="221" name="Group 220"/>
              <p:cNvGrpSpPr/>
              <p:nvPr/>
            </p:nvGrpSpPr>
            <p:grpSpPr>
              <a:xfrm>
                <a:off x="4680983" y="837995"/>
                <a:ext cx="1419373" cy="1342258"/>
                <a:chOff x="2886090" y="2648555"/>
                <a:chExt cx="1419373" cy="1342258"/>
              </a:xfrm>
            </p:grpSpPr>
            <p:pic>
              <p:nvPicPr>
                <p:cNvPr id="238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456" t="4530" b="7604"/>
                <a:stretch/>
              </p:blipFill>
              <p:spPr bwMode="auto">
                <a:xfrm>
                  <a:off x="2886090" y="2648555"/>
                  <a:ext cx="1419373" cy="134225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39" name="Rectangle 238"/>
                <p:cNvSpPr/>
                <p:nvPr/>
              </p:nvSpPr>
              <p:spPr>
                <a:xfrm>
                  <a:off x="3791627" y="3757479"/>
                  <a:ext cx="298757" cy="9401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0" name="TextBox 239"/>
                <p:cNvSpPr txBox="1"/>
                <p:nvPr/>
              </p:nvSpPr>
              <p:spPr>
                <a:xfrm>
                  <a:off x="3670433" y="3265628"/>
                  <a:ext cx="54662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8</a:t>
                  </a:r>
                </a:p>
              </p:txBody>
            </p:sp>
          </p:grpSp>
          <p:grpSp>
            <p:nvGrpSpPr>
              <p:cNvPr id="222" name="Group 221"/>
              <p:cNvGrpSpPr/>
              <p:nvPr/>
            </p:nvGrpSpPr>
            <p:grpSpPr>
              <a:xfrm>
                <a:off x="3361143" y="830401"/>
                <a:ext cx="1704447" cy="1353318"/>
                <a:chOff x="2922035" y="1270729"/>
                <a:chExt cx="1704447" cy="1353318"/>
              </a:xfrm>
            </p:grpSpPr>
            <p:pic>
              <p:nvPicPr>
                <p:cNvPr id="231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457" t="4181" b="7229"/>
                <a:stretch/>
              </p:blipFill>
              <p:spPr bwMode="auto">
                <a:xfrm>
                  <a:off x="2922035" y="1270729"/>
                  <a:ext cx="1404185" cy="135331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32" name="Rectangle 231"/>
                <p:cNvSpPr/>
                <p:nvPr/>
              </p:nvSpPr>
              <p:spPr>
                <a:xfrm>
                  <a:off x="3824689" y="2371049"/>
                  <a:ext cx="283639" cy="853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3" name="TextBox 232"/>
                <p:cNvSpPr txBox="1"/>
                <p:nvPr/>
              </p:nvSpPr>
              <p:spPr>
                <a:xfrm>
                  <a:off x="3738064" y="2279577"/>
                  <a:ext cx="88841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.5</a:t>
                  </a:r>
                </a:p>
              </p:txBody>
            </p:sp>
            <p:sp>
              <p:nvSpPr>
                <p:cNvPr id="234" name="Rectangle 233"/>
                <p:cNvSpPr/>
                <p:nvPr/>
              </p:nvSpPr>
              <p:spPr>
                <a:xfrm>
                  <a:off x="3805409" y="1632593"/>
                  <a:ext cx="234411" cy="8533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5" name="TextBox 234"/>
                <p:cNvSpPr txBox="1"/>
                <p:nvPr/>
              </p:nvSpPr>
              <p:spPr>
                <a:xfrm>
                  <a:off x="3722979" y="1581877"/>
                  <a:ext cx="88841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3</a:t>
                  </a:r>
                </a:p>
              </p:txBody>
            </p:sp>
            <p:sp>
              <p:nvSpPr>
                <p:cNvPr id="236" name="Rectangle 235"/>
                <p:cNvSpPr/>
                <p:nvPr/>
              </p:nvSpPr>
              <p:spPr>
                <a:xfrm>
                  <a:off x="3243946" y="1631664"/>
                  <a:ext cx="213101" cy="4816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7" name="TextBox 236"/>
                <p:cNvSpPr txBox="1"/>
                <p:nvPr/>
              </p:nvSpPr>
              <p:spPr>
                <a:xfrm>
                  <a:off x="3167302" y="1558292"/>
                  <a:ext cx="41105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</p:txBody>
            </p:sp>
          </p:grpSp>
          <p:sp>
            <p:nvSpPr>
              <p:cNvPr id="223" name="TextBox 222"/>
              <p:cNvSpPr txBox="1"/>
              <p:nvPr/>
            </p:nvSpPr>
            <p:spPr>
              <a:xfrm>
                <a:off x="3853786" y="670523"/>
                <a:ext cx="474491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CR6</a:t>
                </a:r>
                <a:r>
                  <a:rPr lang="en-GB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5191475" y="670523"/>
                <a:ext cx="474491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CR6</a:t>
                </a:r>
                <a:r>
                  <a:rPr lang="en-GB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5" name="Group 224"/>
              <p:cNvGrpSpPr/>
              <p:nvPr/>
            </p:nvGrpSpPr>
            <p:grpSpPr>
              <a:xfrm>
                <a:off x="4175734" y="2152087"/>
                <a:ext cx="1214265" cy="153888"/>
                <a:chOff x="3491923" y="2304457"/>
                <a:chExt cx="1214265" cy="153888"/>
              </a:xfrm>
            </p:grpSpPr>
            <p:sp>
              <p:nvSpPr>
                <p:cNvPr id="229" name="TextBox 228"/>
                <p:cNvSpPr txBox="1"/>
                <p:nvPr/>
              </p:nvSpPr>
              <p:spPr>
                <a:xfrm>
                  <a:off x="3491923" y="2304457"/>
                  <a:ext cx="116471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FN</a:t>
                  </a:r>
                  <a:r>
                    <a:rPr lang="en-GB" sz="1000" b="1" dirty="0" err="1">
                      <a:latin typeface="Symbol" panose="05050102010706020507" pitchFamily="18" charset="2"/>
                      <a:cs typeface="Arial" panose="020B0604020202020204" pitchFamily="34" charset="0"/>
                    </a:rPr>
                    <a:t>g</a:t>
                  </a:r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apture </a:t>
                  </a:r>
                </a:p>
              </p:txBody>
            </p:sp>
            <p:cxnSp>
              <p:nvCxnSpPr>
                <p:cNvPr id="230" name="Straight Arrow Connector 229"/>
                <p:cNvCxnSpPr/>
                <p:nvPr/>
              </p:nvCxnSpPr>
              <p:spPr>
                <a:xfrm>
                  <a:off x="4274188" y="2395750"/>
                  <a:ext cx="432000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6" name="Group 225"/>
              <p:cNvGrpSpPr/>
              <p:nvPr/>
            </p:nvGrpSpPr>
            <p:grpSpPr>
              <a:xfrm>
                <a:off x="3163655" y="771465"/>
                <a:ext cx="246221" cy="1446225"/>
                <a:chOff x="2377232" y="712575"/>
                <a:chExt cx="246221" cy="1446225"/>
              </a:xfrm>
            </p:grpSpPr>
            <p:sp>
              <p:nvSpPr>
                <p:cNvPr id="227" name="TextBox 226"/>
                <p:cNvSpPr txBox="1"/>
                <p:nvPr/>
              </p:nvSpPr>
              <p:spPr>
                <a:xfrm rot="16200000">
                  <a:off x="1944862" y="1480209"/>
                  <a:ext cx="111096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-17A capture</a:t>
                  </a:r>
                </a:p>
              </p:txBody>
            </p:sp>
            <p:cxnSp>
              <p:nvCxnSpPr>
                <p:cNvPr id="228" name="Straight Arrow Connector 227"/>
                <p:cNvCxnSpPr/>
                <p:nvPr/>
              </p:nvCxnSpPr>
              <p:spPr>
                <a:xfrm rot="16200000">
                  <a:off x="2301576" y="928575"/>
                  <a:ext cx="432000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03" name="TextBox 102"/>
            <p:cNvSpPr txBox="1"/>
            <p:nvPr/>
          </p:nvSpPr>
          <p:spPr>
            <a:xfrm>
              <a:off x="793919" y="377718"/>
              <a:ext cx="139477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777472" y="2260738"/>
              <a:ext cx="139477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766576" y="2410214"/>
              <a:ext cx="3156156" cy="3269977"/>
              <a:chOff x="2715727" y="2934089"/>
              <a:chExt cx="3156156" cy="3269977"/>
            </a:xfrm>
          </p:grpSpPr>
          <p:grpSp>
            <p:nvGrpSpPr>
              <p:cNvPr id="112" name="Group 111"/>
              <p:cNvGrpSpPr/>
              <p:nvPr/>
            </p:nvGrpSpPr>
            <p:grpSpPr>
              <a:xfrm rot="16200000">
                <a:off x="1708437" y="4239383"/>
                <a:ext cx="2168467" cy="153888"/>
                <a:chOff x="-579436" y="3001410"/>
                <a:chExt cx="2168467" cy="153888"/>
              </a:xfrm>
            </p:grpSpPr>
            <p:sp>
              <p:nvSpPr>
                <p:cNvPr id="217" name="TextBox 216"/>
                <p:cNvSpPr txBox="1"/>
                <p:nvPr/>
              </p:nvSpPr>
              <p:spPr>
                <a:xfrm>
                  <a:off x="-579436" y="3001410"/>
                  <a:ext cx="166400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RNA expression (relative) </a:t>
                  </a:r>
                </a:p>
              </p:txBody>
            </p:sp>
            <p:cxnSp>
              <p:nvCxnSpPr>
                <p:cNvPr id="218" name="Straight Arrow Connector 217"/>
                <p:cNvCxnSpPr/>
                <p:nvPr/>
              </p:nvCxnSpPr>
              <p:spPr>
                <a:xfrm>
                  <a:off x="1157031" y="3084441"/>
                  <a:ext cx="432000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3" name="Rectangle 112"/>
              <p:cNvSpPr/>
              <p:nvPr/>
            </p:nvSpPr>
            <p:spPr>
              <a:xfrm>
                <a:off x="3601879" y="4427461"/>
                <a:ext cx="397545" cy="153888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BX21</a:t>
                </a:r>
                <a:endParaRPr lang="en-GB" sz="1000" dirty="0"/>
              </a:p>
            </p:txBody>
          </p:sp>
          <p:sp>
            <p:nvSpPr>
              <p:cNvPr id="114" name="Rectangle 113"/>
              <p:cNvSpPr/>
              <p:nvPr/>
            </p:nvSpPr>
            <p:spPr>
              <a:xfrm>
                <a:off x="3381481" y="4096612"/>
                <a:ext cx="1083153" cy="127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115" name="Group 114"/>
              <p:cNvGrpSpPr/>
              <p:nvPr/>
            </p:nvGrpSpPr>
            <p:grpSpPr>
              <a:xfrm>
                <a:off x="2925825" y="5733846"/>
                <a:ext cx="2758179" cy="470220"/>
                <a:chOff x="3431547" y="5415585"/>
                <a:chExt cx="2758179" cy="470220"/>
              </a:xfrm>
            </p:grpSpPr>
            <p:sp>
              <p:nvSpPr>
                <p:cNvPr id="182" name="TextBox 181"/>
                <p:cNvSpPr txBox="1"/>
                <p:nvPr/>
              </p:nvSpPr>
              <p:spPr>
                <a:xfrm>
                  <a:off x="3431547" y="5424140"/>
                  <a:ext cx="398996" cy="46166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>
                    <a:tabLst>
                      <a:tab pos="628650" algn="l"/>
                      <a:tab pos="715963" algn="l"/>
                      <a:tab pos="808038" algn="l"/>
                      <a:tab pos="895350" algn="l"/>
                      <a:tab pos="987425" algn="l"/>
                      <a:tab pos="1077913" algn="l"/>
                      <a:tab pos="1165225" algn="l"/>
                      <a:tab pos="1257300" algn="l"/>
                      <a:tab pos="1344613" algn="l"/>
                      <a:tab pos="1436688" algn="l"/>
                      <a:tab pos="1524000" algn="l"/>
                      <a:tab pos="2152650" algn="l"/>
                      <a:tab pos="2419350" algn="l"/>
                      <a:tab pos="2689225" algn="l"/>
                      <a:tab pos="2960688" algn="l"/>
                    </a:tabLst>
                  </a:pPr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R6</a:t>
                  </a:r>
                </a:p>
                <a:p>
                  <a:pPr>
                    <a:tabLst>
                      <a:tab pos="628650" algn="l"/>
                      <a:tab pos="715963" algn="l"/>
                      <a:tab pos="808038" algn="l"/>
                      <a:tab pos="895350" algn="l"/>
                      <a:tab pos="987425" algn="l"/>
                      <a:tab pos="1077913" algn="l"/>
                      <a:tab pos="1165225" algn="l"/>
                      <a:tab pos="1257300" algn="l"/>
                      <a:tab pos="1344613" algn="l"/>
                      <a:tab pos="1436688" algn="l"/>
                      <a:tab pos="1524000" algn="l"/>
                      <a:tab pos="2152650" algn="l"/>
                      <a:tab pos="2419350" algn="l"/>
                      <a:tab pos="2689225" algn="l"/>
                      <a:tab pos="2960688" algn="l"/>
                    </a:tabLst>
                  </a:pPr>
                  <a:r>
                    <a:rPr lang="en-GB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FN</a:t>
                  </a:r>
                  <a:r>
                    <a:rPr lang="en-GB" sz="1000" b="1" dirty="0" err="1">
                      <a:latin typeface="Symbol" panose="05050102010706020507" pitchFamily="18" charset="2"/>
                      <a:cs typeface="Arial" panose="020B0604020202020204" pitchFamily="34" charset="0"/>
                    </a:rPr>
                    <a:t>g</a:t>
                  </a:r>
                  <a:endParaRPr lang="en-GB" sz="1000" b="1" dirty="0">
                    <a:latin typeface="Symbol" panose="05050102010706020507" pitchFamily="18" charset="2"/>
                    <a:cs typeface="Arial" panose="020B0604020202020204" pitchFamily="34" charset="0"/>
                  </a:endParaRPr>
                </a:p>
                <a:p>
                  <a:pPr>
                    <a:tabLst>
                      <a:tab pos="628650" algn="l"/>
                      <a:tab pos="715963" algn="l"/>
                      <a:tab pos="808038" algn="l"/>
                      <a:tab pos="895350" algn="l"/>
                      <a:tab pos="987425" algn="l"/>
                      <a:tab pos="1077913" algn="l"/>
                      <a:tab pos="1165225" algn="l"/>
                      <a:tab pos="1257300" algn="l"/>
                      <a:tab pos="1344613" algn="l"/>
                      <a:tab pos="1436688" algn="l"/>
                      <a:tab pos="1524000" algn="l"/>
                      <a:tab pos="2152650" algn="l"/>
                      <a:tab pos="2419350" algn="l"/>
                      <a:tab pos="2689225" algn="l"/>
                      <a:tab pos="2960688" algn="l"/>
                    </a:tabLst>
                  </a:pPr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-17A</a:t>
                  </a:r>
                </a:p>
              </p:txBody>
            </p:sp>
            <p:grpSp>
              <p:nvGrpSpPr>
                <p:cNvPr id="183" name="Group 182"/>
                <p:cNvGrpSpPr/>
                <p:nvPr/>
              </p:nvGrpSpPr>
              <p:grpSpPr>
                <a:xfrm>
                  <a:off x="3862109" y="5415585"/>
                  <a:ext cx="886892" cy="468416"/>
                  <a:chOff x="3927427" y="5415585"/>
                  <a:chExt cx="886892" cy="468416"/>
                </a:xfrm>
              </p:grpSpPr>
              <p:grpSp>
                <p:nvGrpSpPr>
                  <p:cNvPr id="201" name="Group 200"/>
                  <p:cNvGrpSpPr/>
                  <p:nvPr/>
                </p:nvGrpSpPr>
                <p:grpSpPr>
                  <a:xfrm>
                    <a:off x="4468461" y="5425313"/>
                    <a:ext cx="75342" cy="448960"/>
                    <a:chOff x="2180278" y="5374891"/>
                    <a:chExt cx="75342" cy="448960"/>
                  </a:xfrm>
                </p:grpSpPr>
                <p:sp>
                  <p:nvSpPr>
                    <p:cNvPr id="214" name="Rectangle 213"/>
                    <p:cNvSpPr/>
                    <p:nvPr/>
                  </p:nvSpPr>
                  <p:spPr>
                    <a:xfrm>
                      <a:off x="2180278" y="53748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215" name="Rectangle 214"/>
                    <p:cNvSpPr/>
                    <p:nvPr/>
                  </p:nvSpPr>
                  <p:spPr>
                    <a:xfrm>
                      <a:off x="2180278" y="55272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216" name="Rectangle 215"/>
                    <p:cNvSpPr/>
                    <p:nvPr/>
                  </p:nvSpPr>
                  <p:spPr>
                    <a:xfrm>
                      <a:off x="2190006" y="5669963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</p:grpSp>
              <p:grpSp>
                <p:nvGrpSpPr>
                  <p:cNvPr id="202" name="Group 201"/>
                  <p:cNvGrpSpPr/>
                  <p:nvPr/>
                </p:nvGrpSpPr>
                <p:grpSpPr>
                  <a:xfrm>
                    <a:off x="4738977" y="5415585"/>
                    <a:ext cx="75342" cy="458688"/>
                    <a:chOff x="2180278" y="5365163"/>
                    <a:chExt cx="75342" cy="458688"/>
                  </a:xfrm>
                </p:grpSpPr>
                <p:sp>
                  <p:nvSpPr>
                    <p:cNvPr id="211" name="Rectangle 210"/>
                    <p:cNvSpPr/>
                    <p:nvPr/>
                  </p:nvSpPr>
                  <p:spPr>
                    <a:xfrm>
                      <a:off x="2190006" y="5365163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  <p:sp>
                  <p:nvSpPr>
                    <p:cNvPr id="212" name="Rectangle 211"/>
                    <p:cNvSpPr/>
                    <p:nvPr/>
                  </p:nvSpPr>
                  <p:spPr>
                    <a:xfrm>
                      <a:off x="2180278" y="55272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213" name="Rectangle 212"/>
                    <p:cNvSpPr/>
                    <p:nvPr/>
                  </p:nvSpPr>
                  <p:spPr>
                    <a:xfrm>
                      <a:off x="2190006" y="5669963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</p:grpSp>
              <p:grpSp>
                <p:nvGrpSpPr>
                  <p:cNvPr id="203" name="Group 202"/>
                  <p:cNvGrpSpPr/>
                  <p:nvPr/>
                </p:nvGrpSpPr>
                <p:grpSpPr>
                  <a:xfrm>
                    <a:off x="4197944" y="5425313"/>
                    <a:ext cx="75342" cy="458688"/>
                    <a:chOff x="2180278" y="5374891"/>
                    <a:chExt cx="75342" cy="458688"/>
                  </a:xfrm>
                </p:grpSpPr>
                <p:sp>
                  <p:nvSpPr>
                    <p:cNvPr id="208" name="Rectangle 207"/>
                    <p:cNvSpPr/>
                    <p:nvPr/>
                  </p:nvSpPr>
                  <p:spPr>
                    <a:xfrm>
                      <a:off x="2180278" y="53748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209" name="Rectangle 208"/>
                    <p:cNvSpPr/>
                    <p:nvPr/>
                  </p:nvSpPr>
                  <p:spPr>
                    <a:xfrm>
                      <a:off x="2180278" y="55272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210" name="Rectangle 209"/>
                    <p:cNvSpPr/>
                    <p:nvPr/>
                  </p:nvSpPr>
                  <p:spPr>
                    <a:xfrm>
                      <a:off x="2180278" y="56796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</p:grpSp>
              <p:grpSp>
                <p:nvGrpSpPr>
                  <p:cNvPr id="204" name="Group 203"/>
                  <p:cNvGrpSpPr/>
                  <p:nvPr/>
                </p:nvGrpSpPr>
                <p:grpSpPr>
                  <a:xfrm>
                    <a:off x="3927427" y="5425313"/>
                    <a:ext cx="75342" cy="458688"/>
                    <a:chOff x="2180278" y="5374891"/>
                    <a:chExt cx="75342" cy="458688"/>
                  </a:xfrm>
                </p:grpSpPr>
                <p:sp>
                  <p:nvSpPr>
                    <p:cNvPr id="205" name="Rectangle 204"/>
                    <p:cNvSpPr/>
                    <p:nvPr/>
                  </p:nvSpPr>
                  <p:spPr>
                    <a:xfrm>
                      <a:off x="2180278" y="53748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206" name="Rectangle 205"/>
                    <p:cNvSpPr/>
                    <p:nvPr/>
                  </p:nvSpPr>
                  <p:spPr>
                    <a:xfrm>
                      <a:off x="2190006" y="5527291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  <p:sp>
                  <p:nvSpPr>
                    <p:cNvPr id="207" name="Rectangle 206"/>
                    <p:cNvSpPr/>
                    <p:nvPr/>
                  </p:nvSpPr>
                  <p:spPr>
                    <a:xfrm>
                      <a:off x="2180278" y="56796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</p:grpSp>
            </p:grpSp>
            <p:grpSp>
              <p:nvGrpSpPr>
                <p:cNvPr id="184" name="Group 183"/>
                <p:cNvGrpSpPr/>
                <p:nvPr/>
              </p:nvGrpSpPr>
              <p:grpSpPr>
                <a:xfrm>
                  <a:off x="5302834" y="5415585"/>
                  <a:ext cx="886892" cy="468416"/>
                  <a:chOff x="3927427" y="5415585"/>
                  <a:chExt cx="886892" cy="468416"/>
                </a:xfrm>
              </p:grpSpPr>
              <p:grpSp>
                <p:nvGrpSpPr>
                  <p:cNvPr id="185" name="Group 184"/>
                  <p:cNvGrpSpPr/>
                  <p:nvPr/>
                </p:nvGrpSpPr>
                <p:grpSpPr>
                  <a:xfrm>
                    <a:off x="4468461" y="5425313"/>
                    <a:ext cx="75342" cy="448960"/>
                    <a:chOff x="2180278" y="5374891"/>
                    <a:chExt cx="75342" cy="448960"/>
                  </a:xfrm>
                </p:grpSpPr>
                <p:sp>
                  <p:nvSpPr>
                    <p:cNvPr id="198" name="Rectangle 197"/>
                    <p:cNvSpPr/>
                    <p:nvPr/>
                  </p:nvSpPr>
                  <p:spPr>
                    <a:xfrm>
                      <a:off x="2180278" y="53748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199" name="Rectangle 198"/>
                    <p:cNvSpPr/>
                    <p:nvPr/>
                  </p:nvSpPr>
                  <p:spPr>
                    <a:xfrm>
                      <a:off x="2180278" y="55272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200" name="Rectangle 199"/>
                    <p:cNvSpPr/>
                    <p:nvPr/>
                  </p:nvSpPr>
                  <p:spPr>
                    <a:xfrm>
                      <a:off x="2190006" y="5669963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</p:grpSp>
              <p:grpSp>
                <p:nvGrpSpPr>
                  <p:cNvPr id="186" name="Group 185"/>
                  <p:cNvGrpSpPr/>
                  <p:nvPr/>
                </p:nvGrpSpPr>
                <p:grpSpPr>
                  <a:xfrm>
                    <a:off x="4738977" y="5415585"/>
                    <a:ext cx="75342" cy="458688"/>
                    <a:chOff x="2180278" y="5365163"/>
                    <a:chExt cx="75342" cy="458688"/>
                  </a:xfrm>
                </p:grpSpPr>
                <p:sp>
                  <p:nvSpPr>
                    <p:cNvPr id="195" name="Rectangle 194"/>
                    <p:cNvSpPr/>
                    <p:nvPr/>
                  </p:nvSpPr>
                  <p:spPr>
                    <a:xfrm>
                      <a:off x="2190006" y="5365163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  <p:sp>
                  <p:nvSpPr>
                    <p:cNvPr id="196" name="Rectangle 195"/>
                    <p:cNvSpPr/>
                    <p:nvPr/>
                  </p:nvSpPr>
                  <p:spPr>
                    <a:xfrm>
                      <a:off x="2180278" y="55272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197" name="Rectangle 196"/>
                    <p:cNvSpPr/>
                    <p:nvPr/>
                  </p:nvSpPr>
                  <p:spPr>
                    <a:xfrm>
                      <a:off x="2190006" y="5669963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</p:grpSp>
              <p:grpSp>
                <p:nvGrpSpPr>
                  <p:cNvPr id="187" name="Group 186"/>
                  <p:cNvGrpSpPr/>
                  <p:nvPr/>
                </p:nvGrpSpPr>
                <p:grpSpPr>
                  <a:xfrm>
                    <a:off x="4197944" y="5425313"/>
                    <a:ext cx="75342" cy="458688"/>
                    <a:chOff x="2180278" y="5374891"/>
                    <a:chExt cx="75342" cy="458688"/>
                  </a:xfrm>
                </p:grpSpPr>
                <p:sp>
                  <p:nvSpPr>
                    <p:cNvPr id="192" name="Rectangle 191"/>
                    <p:cNvSpPr/>
                    <p:nvPr/>
                  </p:nvSpPr>
                  <p:spPr>
                    <a:xfrm>
                      <a:off x="2180278" y="53748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193" name="Rectangle 192"/>
                    <p:cNvSpPr/>
                    <p:nvPr/>
                  </p:nvSpPr>
                  <p:spPr>
                    <a:xfrm>
                      <a:off x="2180278" y="55272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194" name="Rectangle 193"/>
                    <p:cNvSpPr/>
                    <p:nvPr/>
                  </p:nvSpPr>
                  <p:spPr>
                    <a:xfrm>
                      <a:off x="2180278" y="56796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</p:grpSp>
              <p:grpSp>
                <p:nvGrpSpPr>
                  <p:cNvPr id="188" name="Group 187"/>
                  <p:cNvGrpSpPr/>
                  <p:nvPr/>
                </p:nvGrpSpPr>
                <p:grpSpPr>
                  <a:xfrm>
                    <a:off x="3927427" y="5425313"/>
                    <a:ext cx="75342" cy="458688"/>
                    <a:chOff x="2180278" y="5374891"/>
                    <a:chExt cx="75342" cy="458688"/>
                  </a:xfrm>
                </p:grpSpPr>
                <p:sp>
                  <p:nvSpPr>
                    <p:cNvPr id="189" name="Rectangle 188"/>
                    <p:cNvSpPr/>
                    <p:nvPr/>
                  </p:nvSpPr>
                  <p:spPr>
                    <a:xfrm>
                      <a:off x="2180278" y="53748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  <p:sp>
                  <p:nvSpPr>
                    <p:cNvPr id="190" name="Rectangle 189"/>
                    <p:cNvSpPr/>
                    <p:nvPr/>
                  </p:nvSpPr>
                  <p:spPr>
                    <a:xfrm>
                      <a:off x="2190006" y="5527291"/>
                      <a:ext cx="4328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dirty="0"/>
                    </a:p>
                  </p:txBody>
                </p:sp>
                <p:sp>
                  <p:nvSpPr>
                    <p:cNvPr id="191" name="Rectangle 190"/>
                    <p:cNvSpPr/>
                    <p:nvPr/>
                  </p:nvSpPr>
                  <p:spPr>
                    <a:xfrm>
                      <a:off x="2180278" y="5679691"/>
                      <a:ext cx="75342" cy="153888"/>
                    </a:xfrm>
                    <a:prstGeom prst="rect">
                      <a:avLst/>
                    </a:prstGeom>
                  </p:spPr>
                  <p:txBody>
                    <a:bodyPr wrap="none" lIns="0" tIns="0" rIns="0" bIns="0">
                      <a:spAutoFit/>
                    </a:bodyPr>
                    <a:lstStyle/>
                    <a:p>
                      <a:r>
                        <a:rPr lang="en-GB" sz="1000" b="1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dirty="0"/>
                    </a:p>
                  </p:txBody>
                </p:sp>
              </p:grpSp>
            </p:grpSp>
          </p:grpSp>
          <p:sp>
            <p:nvSpPr>
              <p:cNvPr id="119" name="Rectangle 118"/>
              <p:cNvSpPr/>
              <p:nvPr/>
            </p:nvSpPr>
            <p:spPr>
              <a:xfrm>
                <a:off x="5042184" y="4427461"/>
                <a:ext cx="378309" cy="153888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ORC</a:t>
                </a:r>
                <a:endParaRPr lang="en-GB" sz="1000" dirty="0"/>
              </a:p>
            </p:txBody>
          </p:sp>
          <p:sp>
            <p:nvSpPr>
              <p:cNvPr id="123" name="Rectangle 122"/>
              <p:cNvSpPr/>
              <p:nvPr/>
            </p:nvSpPr>
            <p:spPr>
              <a:xfrm>
                <a:off x="5095384" y="2934178"/>
                <a:ext cx="347852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IL17A</a:t>
                </a:r>
                <a:endParaRPr lang="en-GB" sz="1000" dirty="0"/>
              </a:p>
            </p:txBody>
          </p:sp>
          <p:sp>
            <p:nvSpPr>
              <p:cNvPr id="125" name="Rectangle 124"/>
              <p:cNvSpPr/>
              <p:nvPr/>
            </p:nvSpPr>
            <p:spPr>
              <a:xfrm>
                <a:off x="3670649" y="2934178"/>
                <a:ext cx="306174" cy="153888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FNG</a:t>
                </a:r>
                <a:endParaRPr lang="en-GB" sz="1000" dirty="0"/>
              </a:p>
            </p:txBody>
          </p:sp>
          <p:grpSp>
            <p:nvGrpSpPr>
              <p:cNvPr id="126" name="Group 125"/>
              <p:cNvGrpSpPr/>
              <p:nvPr/>
            </p:nvGrpSpPr>
            <p:grpSpPr>
              <a:xfrm>
                <a:off x="3393990" y="3214478"/>
                <a:ext cx="270000" cy="111943"/>
                <a:chOff x="3794467" y="2931184"/>
                <a:chExt cx="270000" cy="111943"/>
              </a:xfrm>
            </p:grpSpPr>
            <p:sp>
              <p:nvSpPr>
                <p:cNvPr id="142" name="Left Bracket 141"/>
                <p:cNvSpPr/>
                <p:nvPr/>
              </p:nvSpPr>
              <p:spPr>
                <a:xfrm rot="5400000">
                  <a:off x="3911467" y="2883348"/>
                  <a:ext cx="36000" cy="270000"/>
                </a:xfrm>
                <a:prstGeom prst="leftBracke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43" name="TextBox 142"/>
                <p:cNvSpPr txBox="1"/>
                <p:nvPr/>
              </p:nvSpPr>
              <p:spPr>
                <a:xfrm>
                  <a:off x="3865478" y="2931184"/>
                  <a:ext cx="145486" cy="11194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 anchor="t" anchorCtr="0">
                  <a:noAutofit/>
                </a:bodyPr>
                <a:lstStyle/>
                <a:p>
                  <a:pPr algn="ctr"/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grpSp>
            <p:nvGrpSpPr>
              <p:cNvPr id="127" name="Group 126"/>
              <p:cNvGrpSpPr/>
              <p:nvPr/>
            </p:nvGrpSpPr>
            <p:grpSpPr>
              <a:xfrm>
                <a:off x="3395488" y="3147745"/>
                <a:ext cx="540000" cy="111943"/>
                <a:chOff x="3795965" y="2852615"/>
                <a:chExt cx="540000" cy="111943"/>
              </a:xfrm>
            </p:grpSpPr>
            <p:sp>
              <p:nvSpPr>
                <p:cNvPr id="140" name="Left Bracket 139"/>
                <p:cNvSpPr/>
                <p:nvPr/>
              </p:nvSpPr>
              <p:spPr>
                <a:xfrm rot="5400000">
                  <a:off x="4047965" y="2666964"/>
                  <a:ext cx="36000" cy="540000"/>
                </a:xfrm>
                <a:prstGeom prst="leftBracke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3954839" y="2852615"/>
                  <a:ext cx="222253" cy="11194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 anchor="t" anchorCtr="0">
                  <a:noAutofit/>
                </a:bodyPr>
                <a:lstStyle/>
                <a:p>
                  <a:pPr algn="ctr"/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128" name="Group 127"/>
              <p:cNvGrpSpPr/>
              <p:nvPr/>
            </p:nvGrpSpPr>
            <p:grpSpPr>
              <a:xfrm>
                <a:off x="3393289" y="3072302"/>
                <a:ext cx="810000" cy="111943"/>
                <a:chOff x="3793766" y="2765336"/>
                <a:chExt cx="810000" cy="111943"/>
              </a:xfrm>
            </p:grpSpPr>
            <p:sp>
              <p:nvSpPr>
                <p:cNvPr id="138" name="Left Bracket 137"/>
                <p:cNvSpPr/>
                <p:nvPr/>
              </p:nvSpPr>
              <p:spPr>
                <a:xfrm rot="5400000">
                  <a:off x="4180766" y="2444685"/>
                  <a:ext cx="36000" cy="810000"/>
                </a:xfrm>
                <a:prstGeom prst="leftBracke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>
                  <a:off x="4087640" y="2765336"/>
                  <a:ext cx="222253" cy="11194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 anchor="t" anchorCtr="0">
                  <a:noAutofit/>
                </a:bodyPr>
                <a:lstStyle/>
                <a:p>
                  <a:pPr algn="ctr"/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129" name="Group 128"/>
              <p:cNvGrpSpPr/>
              <p:nvPr/>
            </p:nvGrpSpPr>
            <p:grpSpPr>
              <a:xfrm>
                <a:off x="3659570" y="3275385"/>
                <a:ext cx="270000" cy="111943"/>
                <a:chOff x="3946867" y="3083584"/>
                <a:chExt cx="270000" cy="111943"/>
              </a:xfrm>
            </p:grpSpPr>
            <p:sp>
              <p:nvSpPr>
                <p:cNvPr id="136" name="Left Bracket 135"/>
                <p:cNvSpPr/>
                <p:nvPr/>
              </p:nvSpPr>
              <p:spPr>
                <a:xfrm rot="5400000">
                  <a:off x="4063867" y="3035748"/>
                  <a:ext cx="36000" cy="270000"/>
                </a:xfrm>
                <a:prstGeom prst="leftBracke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4035632" y="3083584"/>
                  <a:ext cx="98402" cy="11194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 anchor="t" anchorCtr="0">
                  <a:noAutofit/>
                </a:bodyPr>
                <a:lstStyle/>
                <a:p>
                  <a:pPr algn="ctr"/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71520" y="4308583"/>
                <a:ext cx="1600200" cy="14763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81221" y="2934089"/>
                <a:ext cx="1490662" cy="14763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6" name="Picture 4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43409" y="2935274"/>
                <a:ext cx="1490662" cy="14763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7" name="Picture 5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33860" y="4311626"/>
                <a:ext cx="1600200" cy="14763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5" name="Rectangle 4"/>
            <p:cNvSpPr/>
            <p:nvPr/>
          </p:nvSpPr>
          <p:spPr>
            <a:xfrm>
              <a:off x="728857" y="5922963"/>
              <a:ext cx="5430610" cy="338554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200000"/>
                </a:lnSpc>
                <a:spcAft>
                  <a:spcPts val="0"/>
                </a:spcAft>
              </a:pP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Figure S1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. 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CCR6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IFN</a:t>
              </a:r>
              <a:r>
                <a:rPr lang="en-GB" sz="1200" b="1" dirty="0">
                  <a:latin typeface="Symbol"/>
                  <a:ea typeface="Calibri"/>
                  <a:cs typeface="Times New Roman"/>
                </a:rPr>
                <a:t>g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 CD4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 memory T cell express both Th1 and Th17 lineage markers.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/>
              </a:r>
              <a:br>
                <a:rPr lang="en-GB" sz="1200" dirty="0">
                  <a:latin typeface="Times New Roman"/>
                  <a:ea typeface="Calibri"/>
                  <a:cs typeface="Times New Roman"/>
                </a:rPr>
              </a:b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A.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Gating strategy to isolate CCR6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and CCR6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-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populations based on </a:t>
              </a:r>
              <a:r>
                <a:rPr lang="en-GB" sz="1200" dirty="0" err="1">
                  <a:latin typeface="Times New Roman"/>
                  <a:ea typeface="Calibri"/>
                  <a:cs typeface="Times New Roman"/>
                </a:rPr>
                <a:t>IFNγ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and IL-17 cytokine capture staining. 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B.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</a:t>
              </a:r>
              <a:r>
                <a:rPr lang="en-GB" sz="1200" dirty="0" err="1">
                  <a:latin typeface="Times New Roman"/>
                  <a:ea typeface="Calibri"/>
                  <a:cs typeface="Times New Roman"/>
                </a:rPr>
                <a:t>qRT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-PCR assessment of mRNA from CCR6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and CCR6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-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expressing </a:t>
              </a:r>
              <a:r>
                <a:rPr lang="en-GB" sz="1200" dirty="0" err="1">
                  <a:latin typeface="Times New Roman"/>
                  <a:ea typeface="Calibri"/>
                  <a:cs typeface="Times New Roman"/>
                </a:rPr>
                <a:t>IFNγ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and IL-17 secreting populations (as indicated); </a:t>
              </a:r>
              <a:r>
                <a:rPr lang="en-GB" sz="1200" i="1" dirty="0">
                  <a:latin typeface="Times New Roman"/>
                  <a:ea typeface="Calibri"/>
                  <a:cs typeface="Times New Roman"/>
                </a:rPr>
                <a:t>IFNG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(n=3), </a:t>
              </a:r>
              <a:r>
                <a:rPr lang="en-GB" sz="1200" i="1" dirty="0">
                  <a:latin typeface="Times New Roman"/>
                  <a:ea typeface="Calibri"/>
                  <a:cs typeface="Times New Roman"/>
                </a:rPr>
                <a:t>IL17A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(n=3), </a:t>
              </a:r>
              <a:r>
                <a:rPr lang="en-GB" sz="1200" i="1" dirty="0">
                  <a:latin typeface="Times New Roman"/>
                  <a:ea typeface="Calibri"/>
                  <a:cs typeface="Times New Roman"/>
                </a:rPr>
                <a:t>TBX21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(n=5) and </a:t>
              </a:r>
              <a:r>
                <a:rPr lang="en-GB" sz="1200" i="1" dirty="0">
                  <a:latin typeface="Times New Roman"/>
                  <a:ea typeface="Calibri"/>
                  <a:cs typeface="Times New Roman"/>
                </a:rPr>
                <a:t>RORC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(n=5) relative to </a:t>
              </a:r>
              <a:r>
                <a:rPr lang="en-GB" sz="1200" i="1" dirty="0">
                  <a:latin typeface="Times New Roman"/>
                  <a:ea typeface="Calibri"/>
                  <a:cs typeface="Times New Roman"/>
                </a:rPr>
                <a:t>GAPDH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. Repeated measures ANOVA with Bonferroni's multiple comparison test; * = p&lt;0.05, ** = p&lt;0.01, *** = p&lt;0.001. All other comparisons were non-significant (p&gt;0.05).</a:t>
              </a:r>
              <a:br>
                <a:rPr lang="en-GB" sz="1200" dirty="0">
                  <a:latin typeface="Times New Roman"/>
                  <a:ea typeface="Calibri"/>
                  <a:cs typeface="Times New Roman"/>
                </a:rPr>
              </a:br>
              <a:endParaRPr lang="en-GB" sz="1100" dirty="0">
                <a:ea typeface="Calibri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30229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1025766" y="580077"/>
            <a:ext cx="4805421" cy="8758279"/>
            <a:chOff x="1025766" y="580077"/>
            <a:chExt cx="4805421" cy="8758279"/>
          </a:xfrm>
        </p:grpSpPr>
        <p:grpSp>
          <p:nvGrpSpPr>
            <p:cNvPr id="2" name="Group 1"/>
            <p:cNvGrpSpPr/>
            <p:nvPr/>
          </p:nvGrpSpPr>
          <p:grpSpPr>
            <a:xfrm>
              <a:off x="2918623" y="580077"/>
              <a:ext cx="2633462" cy="3096352"/>
              <a:chOff x="1074693" y="651327"/>
              <a:chExt cx="2633462" cy="3096352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078791" y="1229270"/>
                <a:ext cx="943665" cy="1078919"/>
                <a:chOff x="788772" y="2588379"/>
                <a:chExt cx="943665" cy="1078919"/>
              </a:xfrm>
            </p:grpSpPr>
            <p:sp>
              <p:nvSpPr>
                <p:cNvPr id="96" name="TextBox 95"/>
                <p:cNvSpPr txBox="1"/>
                <p:nvPr/>
              </p:nvSpPr>
              <p:spPr>
                <a:xfrm>
                  <a:off x="1310934" y="3513410"/>
                  <a:ext cx="42150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-17A</a:t>
                  </a:r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 rot="16200000">
                  <a:off x="586298" y="2790853"/>
                  <a:ext cx="55883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M-CSF</a:t>
                  </a:r>
                </a:p>
              </p:txBody>
            </p:sp>
            <p:grpSp>
              <p:nvGrpSpPr>
                <p:cNvPr id="98" name="Group 97"/>
                <p:cNvGrpSpPr/>
                <p:nvPr/>
              </p:nvGrpSpPr>
              <p:grpSpPr>
                <a:xfrm>
                  <a:off x="862528" y="3167762"/>
                  <a:ext cx="432000" cy="432000"/>
                  <a:chOff x="832676" y="3987905"/>
                  <a:chExt cx="432000" cy="432000"/>
                </a:xfrm>
              </p:grpSpPr>
              <p:cxnSp>
                <p:nvCxnSpPr>
                  <p:cNvPr id="99" name="Straight Arrow Connector 98"/>
                  <p:cNvCxnSpPr/>
                  <p:nvPr/>
                </p:nvCxnSpPr>
                <p:spPr>
                  <a:xfrm rot="16200000">
                    <a:off x="619057" y="4203905"/>
                    <a:ext cx="432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" name="Straight Arrow Connector 99"/>
                  <p:cNvCxnSpPr/>
                  <p:nvPr/>
                </p:nvCxnSpPr>
                <p:spPr>
                  <a:xfrm>
                    <a:off x="832676" y="4416073"/>
                    <a:ext cx="432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7" name="TextBox 6"/>
              <p:cNvSpPr txBox="1"/>
              <p:nvPr/>
            </p:nvSpPr>
            <p:spPr>
              <a:xfrm>
                <a:off x="1092733" y="651327"/>
                <a:ext cx="139477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Group 7"/>
              <p:cNvGrpSpPr/>
              <p:nvPr/>
            </p:nvGrpSpPr>
            <p:grpSpPr>
              <a:xfrm>
                <a:off x="1074693" y="2668760"/>
                <a:ext cx="943665" cy="1078919"/>
                <a:chOff x="788772" y="2588379"/>
                <a:chExt cx="943665" cy="1078919"/>
              </a:xfrm>
            </p:grpSpPr>
            <p:grpSp>
              <p:nvGrpSpPr>
                <p:cNvPr id="91" name="Group 90"/>
                <p:cNvGrpSpPr/>
                <p:nvPr/>
              </p:nvGrpSpPr>
              <p:grpSpPr>
                <a:xfrm>
                  <a:off x="862528" y="3167762"/>
                  <a:ext cx="432000" cy="432000"/>
                  <a:chOff x="832676" y="3987905"/>
                  <a:chExt cx="432000" cy="432000"/>
                </a:xfrm>
              </p:grpSpPr>
              <p:cxnSp>
                <p:nvCxnSpPr>
                  <p:cNvPr id="94" name="Straight Arrow Connector 93"/>
                  <p:cNvCxnSpPr/>
                  <p:nvPr/>
                </p:nvCxnSpPr>
                <p:spPr>
                  <a:xfrm rot="16200000">
                    <a:off x="619057" y="4203905"/>
                    <a:ext cx="432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Straight Arrow Connector 94"/>
                  <p:cNvCxnSpPr/>
                  <p:nvPr/>
                </p:nvCxnSpPr>
                <p:spPr>
                  <a:xfrm>
                    <a:off x="832676" y="4416073"/>
                    <a:ext cx="43200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2" name="TextBox 91"/>
                <p:cNvSpPr txBox="1"/>
                <p:nvPr/>
              </p:nvSpPr>
              <p:spPr>
                <a:xfrm>
                  <a:off x="1310934" y="3513410"/>
                  <a:ext cx="42150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FN</a:t>
                  </a:r>
                  <a:r>
                    <a:rPr lang="en-GB" sz="1000" b="1" dirty="0" err="1">
                      <a:latin typeface="Symbol" panose="05050102010706020507" pitchFamily="18" charset="2"/>
                      <a:cs typeface="Arial" panose="020B0604020202020204" pitchFamily="34" charset="0"/>
                    </a:rPr>
                    <a:t>g</a:t>
                  </a:r>
                  <a:endParaRPr lang="en-GB" sz="1000" b="1" dirty="0">
                    <a:latin typeface="Symbol" panose="05050102010706020507" pitchFamily="18" charset="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 rot="16200000">
                  <a:off x="586298" y="2790853"/>
                  <a:ext cx="55883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M-CSF</a:t>
                  </a:r>
                </a:p>
              </p:txBody>
            </p:sp>
          </p:grpSp>
          <p:pic>
            <p:nvPicPr>
              <p:cNvPr id="9" name="Picture 12"/>
              <p:cNvPicPr>
                <a:picLocks noChangeAspect="1" noChangeArrowheads="1"/>
              </p:cNvPicPr>
              <p:nvPr/>
            </p:nvPicPr>
            <p:blipFill>
              <a:blip r:embed="rId2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49546" y="2421264"/>
                <a:ext cx="1207303" cy="119158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1411534" y="2450824"/>
                <a:ext cx="22498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.9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217019" y="2450824"/>
                <a:ext cx="200755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8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157839" y="3347271"/>
                <a:ext cx="26136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.6</a:t>
                </a:r>
              </a:p>
            </p:txBody>
          </p:sp>
          <p:grpSp>
            <p:nvGrpSpPr>
              <p:cNvPr id="13" name="Group 12"/>
              <p:cNvGrpSpPr/>
              <p:nvPr/>
            </p:nvGrpSpPr>
            <p:grpSpPr>
              <a:xfrm>
                <a:off x="1253422" y="977377"/>
                <a:ext cx="1207303" cy="1193729"/>
                <a:chOff x="2030760" y="1003695"/>
                <a:chExt cx="1207303" cy="1193729"/>
              </a:xfrm>
            </p:grpSpPr>
            <p:pic>
              <p:nvPicPr>
                <p:cNvPr id="87" name="Picture 10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30760" y="1003695"/>
                  <a:ext cx="1207303" cy="119372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8" name="TextBox 87"/>
                <p:cNvSpPr txBox="1"/>
                <p:nvPr/>
              </p:nvSpPr>
              <p:spPr>
                <a:xfrm>
                  <a:off x="2151324" y="1031714"/>
                  <a:ext cx="28628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.7</a:t>
                  </a: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2925317" y="1031714"/>
                  <a:ext cx="296994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4</a:t>
                  </a: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2925317" y="1928294"/>
                  <a:ext cx="26136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2</a:t>
                  </a:r>
                </a:p>
              </p:txBody>
            </p:sp>
          </p:grpSp>
          <p:sp>
            <p:nvSpPr>
              <p:cNvPr id="14" name="TextBox 13"/>
              <p:cNvSpPr txBox="1"/>
              <p:nvPr/>
            </p:nvSpPr>
            <p:spPr>
              <a:xfrm>
                <a:off x="1674597" y="775783"/>
                <a:ext cx="429088" cy="19024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18000" tIns="18000" rIns="18000" bIns="1800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CR6</a:t>
                </a:r>
                <a:r>
                  <a:rPr lang="en-GB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pic>
            <p:nvPicPr>
              <p:cNvPr id="15" name="Picture 11"/>
              <p:cNvPicPr>
                <a:picLocks noChangeAspect="1" noChangeArrowheads="1"/>
              </p:cNvPicPr>
              <p:nvPr/>
            </p:nvPicPr>
            <p:blipFill>
              <a:blip r:embed="rId4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95137" y="2416536"/>
                <a:ext cx="1213018" cy="11965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2663862" y="2450824"/>
                <a:ext cx="191259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.8</a:t>
                </a:r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2487279" y="975949"/>
                <a:ext cx="1220876" cy="1196587"/>
                <a:chOff x="738119" y="1002267"/>
                <a:chExt cx="1220876" cy="1196587"/>
              </a:xfrm>
            </p:grpSpPr>
            <p:pic>
              <p:nvPicPr>
                <p:cNvPr id="83" name="Picture 7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38119" y="1002267"/>
                  <a:ext cx="1220876" cy="119658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4" name="TextBox 83"/>
                <p:cNvSpPr txBox="1"/>
                <p:nvPr/>
              </p:nvSpPr>
              <p:spPr>
                <a:xfrm>
                  <a:off x="1630744" y="1031714"/>
                  <a:ext cx="296994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74</a:t>
                  </a: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1639746" y="1928294"/>
                  <a:ext cx="26136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5</a:t>
                  </a: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875144" y="1031714"/>
                  <a:ext cx="286283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.7</a:t>
                  </a:r>
                </a:p>
              </p:txBody>
            </p:sp>
          </p:grpSp>
          <p:sp>
            <p:nvSpPr>
              <p:cNvPr id="18" name="TextBox 17"/>
              <p:cNvSpPr txBox="1"/>
              <p:nvPr/>
            </p:nvSpPr>
            <p:spPr>
              <a:xfrm>
                <a:off x="2898711" y="776130"/>
                <a:ext cx="435500" cy="19024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none" lIns="18000" tIns="18000" rIns="18000" bIns="1800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CR6</a:t>
                </a:r>
                <a:r>
                  <a:rPr lang="en-GB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450135" y="2450824"/>
                <a:ext cx="18385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.6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450135" y="3347271"/>
                <a:ext cx="21806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.1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2946381" y="3770282"/>
              <a:ext cx="139477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2716598" y="4598016"/>
              <a:ext cx="718145" cy="25648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M-CSF</a:t>
              </a:r>
            </a:p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% positive)</a:t>
              </a: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3852263" y="3913056"/>
              <a:ext cx="540027" cy="168497"/>
              <a:chOff x="3794467" y="2957273"/>
              <a:chExt cx="270000" cy="110645"/>
            </a:xfrm>
          </p:grpSpPr>
          <p:sp>
            <p:nvSpPr>
              <p:cNvPr id="47" name="Left Bracket 46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878254" y="2957273"/>
                <a:ext cx="111677" cy="11064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3583791" y="4074792"/>
              <a:ext cx="270000" cy="111943"/>
              <a:chOff x="3794467" y="2931184"/>
              <a:chExt cx="270000" cy="111943"/>
            </a:xfrm>
          </p:grpSpPr>
          <p:sp>
            <p:nvSpPr>
              <p:cNvPr id="45" name="Left Bracket 44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865478" y="2931184"/>
                <a:ext cx="145486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3853954" y="3997470"/>
              <a:ext cx="270000" cy="111943"/>
              <a:chOff x="3794467" y="2931184"/>
              <a:chExt cx="270000" cy="111943"/>
            </a:xfrm>
          </p:grpSpPr>
          <p:sp>
            <p:nvSpPr>
              <p:cNvPr id="43" name="Left Bracket 42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3865478" y="2931184"/>
                <a:ext cx="145486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101" name="Group 100"/>
            <p:cNvGrpSpPr/>
            <p:nvPr/>
          </p:nvGrpSpPr>
          <p:grpSpPr>
            <a:xfrm>
              <a:off x="3115908" y="5328017"/>
              <a:ext cx="1317454" cy="470220"/>
              <a:chOff x="1126491" y="6015937"/>
              <a:chExt cx="1317454" cy="470220"/>
            </a:xfrm>
          </p:grpSpPr>
          <p:sp>
            <p:nvSpPr>
              <p:cNvPr id="102" name="TextBox 101"/>
              <p:cNvSpPr txBox="1"/>
              <p:nvPr/>
            </p:nvSpPr>
            <p:spPr>
              <a:xfrm>
                <a:off x="1126491" y="6024492"/>
                <a:ext cx="398996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>
                  <a:tabLst>
                    <a:tab pos="628650" algn="l"/>
                    <a:tab pos="715963" algn="l"/>
                    <a:tab pos="808038" algn="l"/>
                    <a:tab pos="895350" algn="l"/>
                    <a:tab pos="987425" algn="l"/>
                    <a:tab pos="1077913" algn="l"/>
                    <a:tab pos="1165225" algn="l"/>
                    <a:tab pos="1257300" algn="l"/>
                    <a:tab pos="1344613" algn="l"/>
                    <a:tab pos="1436688" algn="l"/>
                    <a:tab pos="1524000" algn="l"/>
                    <a:tab pos="2152650" algn="l"/>
                    <a:tab pos="2419350" algn="l"/>
                    <a:tab pos="2689225" algn="l"/>
                    <a:tab pos="2960688" algn="l"/>
                  </a:tabLst>
                </a:pPr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CR6</a:t>
                </a:r>
              </a:p>
              <a:p>
                <a:pPr>
                  <a:tabLst>
                    <a:tab pos="628650" algn="l"/>
                    <a:tab pos="715963" algn="l"/>
                    <a:tab pos="808038" algn="l"/>
                    <a:tab pos="895350" algn="l"/>
                    <a:tab pos="987425" algn="l"/>
                    <a:tab pos="1077913" algn="l"/>
                    <a:tab pos="1165225" algn="l"/>
                    <a:tab pos="1257300" algn="l"/>
                    <a:tab pos="1344613" algn="l"/>
                    <a:tab pos="1436688" algn="l"/>
                    <a:tab pos="1524000" algn="l"/>
                    <a:tab pos="2152650" algn="l"/>
                    <a:tab pos="2419350" algn="l"/>
                    <a:tab pos="2689225" algn="l"/>
                    <a:tab pos="2960688" algn="l"/>
                  </a:tabLst>
                </a:pPr>
                <a:r>
                  <a:rPr lang="en-GB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FN</a:t>
                </a:r>
                <a:r>
                  <a:rPr lang="en-GB" sz="1000" b="1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  <a:endParaRPr lang="en-GB" sz="1000" b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  <a:p>
                <a:pPr>
                  <a:tabLst>
                    <a:tab pos="628650" algn="l"/>
                    <a:tab pos="715963" algn="l"/>
                    <a:tab pos="808038" algn="l"/>
                    <a:tab pos="895350" algn="l"/>
                    <a:tab pos="987425" algn="l"/>
                    <a:tab pos="1077913" algn="l"/>
                    <a:tab pos="1165225" algn="l"/>
                    <a:tab pos="1257300" algn="l"/>
                    <a:tab pos="1344613" algn="l"/>
                    <a:tab pos="1436688" algn="l"/>
                    <a:tab pos="1524000" algn="l"/>
                    <a:tab pos="2152650" algn="l"/>
                    <a:tab pos="2419350" algn="l"/>
                    <a:tab pos="2689225" algn="l"/>
                    <a:tab pos="2960688" algn="l"/>
                  </a:tabLst>
                </a:pPr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L-17A</a:t>
                </a:r>
              </a:p>
            </p:txBody>
          </p:sp>
          <p:grpSp>
            <p:nvGrpSpPr>
              <p:cNvPr id="103" name="Group 102"/>
              <p:cNvGrpSpPr/>
              <p:nvPr/>
            </p:nvGrpSpPr>
            <p:grpSpPr>
              <a:xfrm>
                <a:off x="1557053" y="6015937"/>
                <a:ext cx="886892" cy="468416"/>
                <a:chOff x="3927427" y="5415585"/>
                <a:chExt cx="886892" cy="468416"/>
              </a:xfrm>
            </p:grpSpPr>
            <p:grpSp>
              <p:nvGrpSpPr>
                <p:cNvPr id="104" name="Group 103"/>
                <p:cNvGrpSpPr/>
                <p:nvPr/>
              </p:nvGrpSpPr>
              <p:grpSpPr>
                <a:xfrm>
                  <a:off x="4468461" y="5425313"/>
                  <a:ext cx="75342" cy="448960"/>
                  <a:chOff x="2180278" y="5374891"/>
                  <a:chExt cx="75342" cy="448960"/>
                </a:xfrm>
              </p:grpSpPr>
              <p:sp>
                <p:nvSpPr>
                  <p:cNvPr id="117" name="Rectangle 116"/>
                  <p:cNvSpPr/>
                  <p:nvPr/>
                </p:nvSpPr>
                <p:spPr>
                  <a:xfrm>
                    <a:off x="2180278" y="53748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118" name="Rectangle 117"/>
                  <p:cNvSpPr/>
                  <p:nvPr/>
                </p:nvSpPr>
                <p:spPr>
                  <a:xfrm>
                    <a:off x="2180278" y="55272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119" name="Rectangle 118"/>
                  <p:cNvSpPr/>
                  <p:nvPr/>
                </p:nvSpPr>
                <p:spPr>
                  <a:xfrm>
                    <a:off x="2190006" y="5669963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</p:grpSp>
            <p:grpSp>
              <p:nvGrpSpPr>
                <p:cNvPr id="105" name="Group 104"/>
                <p:cNvGrpSpPr/>
                <p:nvPr/>
              </p:nvGrpSpPr>
              <p:grpSpPr>
                <a:xfrm>
                  <a:off x="4738977" y="5415585"/>
                  <a:ext cx="75342" cy="458688"/>
                  <a:chOff x="2180278" y="5365163"/>
                  <a:chExt cx="75342" cy="458688"/>
                </a:xfrm>
              </p:grpSpPr>
              <p:sp>
                <p:nvSpPr>
                  <p:cNvPr id="114" name="Rectangle 113"/>
                  <p:cNvSpPr/>
                  <p:nvPr/>
                </p:nvSpPr>
                <p:spPr>
                  <a:xfrm>
                    <a:off x="2190006" y="5365163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  <p:sp>
                <p:nvSpPr>
                  <p:cNvPr id="115" name="Rectangle 114"/>
                  <p:cNvSpPr/>
                  <p:nvPr/>
                </p:nvSpPr>
                <p:spPr>
                  <a:xfrm>
                    <a:off x="2180278" y="55272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116" name="Rectangle 115"/>
                  <p:cNvSpPr/>
                  <p:nvPr/>
                </p:nvSpPr>
                <p:spPr>
                  <a:xfrm>
                    <a:off x="2190006" y="5669963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</p:grpSp>
            <p:grpSp>
              <p:nvGrpSpPr>
                <p:cNvPr id="106" name="Group 105"/>
                <p:cNvGrpSpPr/>
                <p:nvPr/>
              </p:nvGrpSpPr>
              <p:grpSpPr>
                <a:xfrm>
                  <a:off x="4197944" y="5425313"/>
                  <a:ext cx="75342" cy="458688"/>
                  <a:chOff x="2180278" y="5374891"/>
                  <a:chExt cx="75342" cy="458688"/>
                </a:xfrm>
              </p:grpSpPr>
              <p:sp>
                <p:nvSpPr>
                  <p:cNvPr id="111" name="Rectangle 110"/>
                  <p:cNvSpPr/>
                  <p:nvPr/>
                </p:nvSpPr>
                <p:spPr>
                  <a:xfrm>
                    <a:off x="2180278" y="53748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112" name="Rectangle 111"/>
                  <p:cNvSpPr/>
                  <p:nvPr/>
                </p:nvSpPr>
                <p:spPr>
                  <a:xfrm>
                    <a:off x="2180278" y="55272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113" name="Rectangle 112"/>
                  <p:cNvSpPr/>
                  <p:nvPr/>
                </p:nvSpPr>
                <p:spPr>
                  <a:xfrm>
                    <a:off x="2180278" y="56796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</p:grpSp>
            <p:grpSp>
              <p:nvGrpSpPr>
                <p:cNvPr id="107" name="Group 106"/>
                <p:cNvGrpSpPr/>
                <p:nvPr/>
              </p:nvGrpSpPr>
              <p:grpSpPr>
                <a:xfrm>
                  <a:off x="3927427" y="5425313"/>
                  <a:ext cx="75342" cy="458688"/>
                  <a:chOff x="2180278" y="5374891"/>
                  <a:chExt cx="75342" cy="458688"/>
                </a:xfrm>
              </p:grpSpPr>
              <p:sp>
                <p:nvSpPr>
                  <p:cNvPr id="108" name="Rectangle 107"/>
                  <p:cNvSpPr/>
                  <p:nvPr/>
                </p:nvSpPr>
                <p:spPr>
                  <a:xfrm>
                    <a:off x="2180278" y="53748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109" name="Rectangle 108"/>
                  <p:cNvSpPr/>
                  <p:nvPr/>
                </p:nvSpPr>
                <p:spPr>
                  <a:xfrm>
                    <a:off x="2190006" y="5527291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  <p:sp>
                <p:nvSpPr>
                  <p:cNvPr id="110" name="Rectangle 109"/>
                  <p:cNvSpPr/>
                  <p:nvPr/>
                </p:nvSpPr>
                <p:spPr>
                  <a:xfrm>
                    <a:off x="2180278" y="56796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</p:grpSp>
          </p:grpSp>
        </p:grpSp>
        <p:grpSp>
          <p:nvGrpSpPr>
            <p:cNvPr id="20" name="Group 19"/>
            <p:cNvGrpSpPr/>
            <p:nvPr/>
          </p:nvGrpSpPr>
          <p:grpSpPr>
            <a:xfrm>
              <a:off x="1729022" y="751960"/>
              <a:ext cx="815264" cy="170474"/>
              <a:chOff x="3794467" y="2957273"/>
              <a:chExt cx="270000" cy="111943"/>
            </a:xfrm>
          </p:grpSpPr>
          <p:sp>
            <p:nvSpPr>
              <p:cNvPr id="81" name="Left Bracket 80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3892883" y="2957273"/>
                <a:ext cx="72743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1262902" y="4689587"/>
              <a:ext cx="1317454" cy="470220"/>
              <a:chOff x="1126491" y="6015937"/>
              <a:chExt cx="1317454" cy="470220"/>
            </a:xfrm>
          </p:grpSpPr>
          <p:sp>
            <p:nvSpPr>
              <p:cNvPr id="63" name="TextBox 62"/>
              <p:cNvSpPr txBox="1"/>
              <p:nvPr/>
            </p:nvSpPr>
            <p:spPr>
              <a:xfrm>
                <a:off x="1126491" y="6024492"/>
                <a:ext cx="398996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>
                  <a:tabLst>
                    <a:tab pos="628650" algn="l"/>
                    <a:tab pos="715963" algn="l"/>
                    <a:tab pos="808038" algn="l"/>
                    <a:tab pos="895350" algn="l"/>
                    <a:tab pos="987425" algn="l"/>
                    <a:tab pos="1077913" algn="l"/>
                    <a:tab pos="1165225" algn="l"/>
                    <a:tab pos="1257300" algn="l"/>
                    <a:tab pos="1344613" algn="l"/>
                    <a:tab pos="1436688" algn="l"/>
                    <a:tab pos="1524000" algn="l"/>
                    <a:tab pos="2152650" algn="l"/>
                    <a:tab pos="2419350" algn="l"/>
                    <a:tab pos="2689225" algn="l"/>
                    <a:tab pos="2960688" algn="l"/>
                  </a:tabLst>
                </a:pPr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CR6</a:t>
                </a:r>
              </a:p>
              <a:p>
                <a:pPr>
                  <a:tabLst>
                    <a:tab pos="628650" algn="l"/>
                    <a:tab pos="715963" algn="l"/>
                    <a:tab pos="808038" algn="l"/>
                    <a:tab pos="895350" algn="l"/>
                    <a:tab pos="987425" algn="l"/>
                    <a:tab pos="1077913" algn="l"/>
                    <a:tab pos="1165225" algn="l"/>
                    <a:tab pos="1257300" algn="l"/>
                    <a:tab pos="1344613" algn="l"/>
                    <a:tab pos="1436688" algn="l"/>
                    <a:tab pos="1524000" algn="l"/>
                    <a:tab pos="2152650" algn="l"/>
                    <a:tab pos="2419350" algn="l"/>
                    <a:tab pos="2689225" algn="l"/>
                    <a:tab pos="2960688" algn="l"/>
                  </a:tabLst>
                </a:pPr>
                <a:r>
                  <a:rPr lang="en-GB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FN</a:t>
                </a:r>
                <a:r>
                  <a:rPr lang="en-GB" sz="1000" b="1" dirty="0" err="1">
                    <a:latin typeface="Symbol" panose="05050102010706020507" pitchFamily="18" charset="2"/>
                    <a:cs typeface="Arial" panose="020B0604020202020204" pitchFamily="34" charset="0"/>
                  </a:rPr>
                  <a:t>g</a:t>
                </a:r>
                <a:endParaRPr lang="en-GB" sz="1000" b="1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  <a:p>
                <a:pPr>
                  <a:tabLst>
                    <a:tab pos="628650" algn="l"/>
                    <a:tab pos="715963" algn="l"/>
                    <a:tab pos="808038" algn="l"/>
                    <a:tab pos="895350" algn="l"/>
                    <a:tab pos="987425" algn="l"/>
                    <a:tab pos="1077913" algn="l"/>
                    <a:tab pos="1165225" algn="l"/>
                    <a:tab pos="1257300" algn="l"/>
                    <a:tab pos="1344613" algn="l"/>
                    <a:tab pos="1436688" algn="l"/>
                    <a:tab pos="1524000" algn="l"/>
                    <a:tab pos="2152650" algn="l"/>
                    <a:tab pos="2419350" algn="l"/>
                    <a:tab pos="2689225" algn="l"/>
                    <a:tab pos="2960688" algn="l"/>
                  </a:tabLst>
                </a:pPr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L-17A</a:t>
                </a:r>
              </a:p>
            </p:txBody>
          </p:sp>
          <p:grpSp>
            <p:nvGrpSpPr>
              <p:cNvPr id="64" name="Group 63"/>
              <p:cNvGrpSpPr/>
              <p:nvPr/>
            </p:nvGrpSpPr>
            <p:grpSpPr>
              <a:xfrm>
                <a:off x="1557053" y="6015937"/>
                <a:ext cx="886892" cy="468416"/>
                <a:chOff x="3927427" y="5415585"/>
                <a:chExt cx="886892" cy="468416"/>
              </a:xfrm>
            </p:grpSpPr>
            <p:grpSp>
              <p:nvGrpSpPr>
                <p:cNvPr id="65" name="Group 64"/>
                <p:cNvGrpSpPr/>
                <p:nvPr/>
              </p:nvGrpSpPr>
              <p:grpSpPr>
                <a:xfrm>
                  <a:off x="4468461" y="5425313"/>
                  <a:ext cx="75342" cy="448960"/>
                  <a:chOff x="2180278" y="5374891"/>
                  <a:chExt cx="75342" cy="448960"/>
                </a:xfrm>
              </p:grpSpPr>
              <p:sp>
                <p:nvSpPr>
                  <p:cNvPr id="78" name="Rectangle 77"/>
                  <p:cNvSpPr/>
                  <p:nvPr/>
                </p:nvSpPr>
                <p:spPr>
                  <a:xfrm>
                    <a:off x="2180278" y="53748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79" name="Rectangle 78"/>
                  <p:cNvSpPr/>
                  <p:nvPr/>
                </p:nvSpPr>
                <p:spPr>
                  <a:xfrm>
                    <a:off x="2180278" y="55272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80" name="Rectangle 79"/>
                  <p:cNvSpPr/>
                  <p:nvPr/>
                </p:nvSpPr>
                <p:spPr>
                  <a:xfrm>
                    <a:off x="2190006" y="5669963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</p:grpSp>
            <p:grpSp>
              <p:nvGrpSpPr>
                <p:cNvPr id="66" name="Group 65"/>
                <p:cNvGrpSpPr/>
                <p:nvPr/>
              </p:nvGrpSpPr>
              <p:grpSpPr>
                <a:xfrm>
                  <a:off x="4738977" y="5415585"/>
                  <a:ext cx="75342" cy="458688"/>
                  <a:chOff x="2180278" y="5365163"/>
                  <a:chExt cx="75342" cy="458688"/>
                </a:xfrm>
              </p:grpSpPr>
              <p:sp>
                <p:nvSpPr>
                  <p:cNvPr id="75" name="Rectangle 74"/>
                  <p:cNvSpPr/>
                  <p:nvPr/>
                </p:nvSpPr>
                <p:spPr>
                  <a:xfrm>
                    <a:off x="2190006" y="5365163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  <p:sp>
                <p:nvSpPr>
                  <p:cNvPr id="76" name="Rectangle 75"/>
                  <p:cNvSpPr/>
                  <p:nvPr/>
                </p:nvSpPr>
                <p:spPr>
                  <a:xfrm>
                    <a:off x="2180278" y="55272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77" name="Rectangle 76"/>
                  <p:cNvSpPr/>
                  <p:nvPr/>
                </p:nvSpPr>
                <p:spPr>
                  <a:xfrm>
                    <a:off x="2190006" y="5669963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</p:grpSp>
            <p:grpSp>
              <p:nvGrpSpPr>
                <p:cNvPr id="67" name="Group 66"/>
                <p:cNvGrpSpPr/>
                <p:nvPr/>
              </p:nvGrpSpPr>
              <p:grpSpPr>
                <a:xfrm>
                  <a:off x="4197944" y="5425313"/>
                  <a:ext cx="75342" cy="458688"/>
                  <a:chOff x="2180278" y="5374891"/>
                  <a:chExt cx="75342" cy="458688"/>
                </a:xfrm>
              </p:grpSpPr>
              <p:sp>
                <p:nvSpPr>
                  <p:cNvPr id="72" name="Rectangle 71"/>
                  <p:cNvSpPr/>
                  <p:nvPr/>
                </p:nvSpPr>
                <p:spPr>
                  <a:xfrm>
                    <a:off x="2180278" y="53748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73" name="Rectangle 72"/>
                  <p:cNvSpPr/>
                  <p:nvPr/>
                </p:nvSpPr>
                <p:spPr>
                  <a:xfrm>
                    <a:off x="2180278" y="55272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74" name="Rectangle 73"/>
                  <p:cNvSpPr/>
                  <p:nvPr/>
                </p:nvSpPr>
                <p:spPr>
                  <a:xfrm>
                    <a:off x="2180278" y="56796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</p:grpSp>
            <p:grpSp>
              <p:nvGrpSpPr>
                <p:cNvPr id="68" name="Group 67"/>
                <p:cNvGrpSpPr/>
                <p:nvPr/>
              </p:nvGrpSpPr>
              <p:grpSpPr>
                <a:xfrm>
                  <a:off x="3927427" y="5425313"/>
                  <a:ext cx="75342" cy="458688"/>
                  <a:chOff x="2180278" y="5374891"/>
                  <a:chExt cx="75342" cy="458688"/>
                </a:xfrm>
              </p:grpSpPr>
              <p:sp>
                <p:nvSpPr>
                  <p:cNvPr id="69" name="Rectangle 68"/>
                  <p:cNvSpPr/>
                  <p:nvPr/>
                </p:nvSpPr>
                <p:spPr>
                  <a:xfrm>
                    <a:off x="2180278" y="53748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  <p:sp>
                <p:nvSpPr>
                  <p:cNvPr id="70" name="Rectangle 69"/>
                  <p:cNvSpPr/>
                  <p:nvPr/>
                </p:nvSpPr>
                <p:spPr>
                  <a:xfrm>
                    <a:off x="2190006" y="5527291"/>
                    <a:ext cx="4328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</a:t>
                    </a:r>
                    <a:endParaRPr lang="en-GB" dirty="0"/>
                  </a:p>
                </p:txBody>
              </p:sp>
              <p:sp>
                <p:nvSpPr>
                  <p:cNvPr id="71" name="Rectangle 70"/>
                  <p:cNvSpPr/>
                  <p:nvPr/>
                </p:nvSpPr>
                <p:spPr>
                  <a:xfrm>
                    <a:off x="2180278" y="5679691"/>
                    <a:ext cx="75342" cy="153888"/>
                  </a:xfrm>
                  <a:prstGeom prst="rect">
                    <a:avLst/>
                  </a:prstGeom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en-GB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dirty="0"/>
                  </a:p>
                </p:txBody>
              </p:sp>
            </p:grpSp>
          </p:grpSp>
        </p:grpSp>
        <p:sp>
          <p:nvSpPr>
            <p:cNvPr id="24" name="TextBox 23"/>
            <p:cNvSpPr txBox="1"/>
            <p:nvPr/>
          </p:nvSpPr>
          <p:spPr>
            <a:xfrm rot="16200000">
              <a:off x="872100" y="1245092"/>
              <a:ext cx="718145" cy="25648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17F</a:t>
              </a:r>
            </a:p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% positive)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872100" y="2596760"/>
              <a:ext cx="718145" cy="25648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21</a:t>
              </a:r>
            </a:p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% positive)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872101" y="3919245"/>
              <a:ext cx="718145" cy="25648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L-22</a:t>
              </a:r>
            </a:p>
            <a:p>
              <a:pPr algn="ctr">
                <a:lnSpc>
                  <a:spcPts val="1000"/>
                </a:lnSpc>
              </a:pP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% positive)</a:t>
              </a: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2002511" y="2215018"/>
              <a:ext cx="270000" cy="111943"/>
              <a:chOff x="3794467" y="2931184"/>
              <a:chExt cx="270000" cy="111943"/>
            </a:xfrm>
          </p:grpSpPr>
          <p:sp>
            <p:nvSpPr>
              <p:cNvPr id="61" name="Left Bracket 60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3865478" y="2931184"/>
                <a:ext cx="145486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2004258" y="2110022"/>
              <a:ext cx="540027" cy="170474"/>
              <a:chOff x="3794467" y="2957273"/>
              <a:chExt cx="270000" cy="111943"/>
            </a:xfrm>
          </p:grpSpPr>
          <p:sp>
            <p:nvSpPr>
              <p:cNvPr id="59" name="Left Bracket 58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3892883" y="2957273"/>
                <a:ext cx="72743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1729021" y="840319"/>
              <a:ext cx="540027" cy="170474"/>
              <a:chOff x="3794467" y="2957273"/>
              <a:chExt cx="270000" cy="111943"/>
            </a:xfrm>
          </p:grpSpPr>
          <p:sp>
            <p:nvSpPr>
              <p:cNvPr id="57" name="Left Bracket 56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3892883" y="2957273"/>
                <a:ext cx="72743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1997371" y="928678"/>
              <a:ext cx="540027" cy="170474"/>
              <a:chOff x="3794467" y="2957273"/>
              <a:chExt cx="270000" cy="111943"/>
            </a:xfrm>
          </p:grpSpPr>
          <p:sp>
            <p:nvSpPr>
              <p:cNvPr id="55" name="Left Bracket 54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3892883" y="2957273"/>
                <a:ext cx="72743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1997959" y="1017038"/>
              <a:ext cx="270000" cy="111943"/>
              <a:chOff x="3794467" y="2931184"/>
              <a:chExt cx="270000" cy="111943"/>
            </a:xfrm>
          </p:grpSpPr>
          <p:sp>
            <p:nvSpPr>
              <p:cNvPr id="53" name="Left Bracket 52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865478" y="2931184"/>
                <a:ext cx="145486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2009869" y="3442069"/>
              <a:ext cx="540027" cy="170474"/>
              <a:chOff x="3794467" y="2957273"/>
              <a:chExt cx="270000" cy="111943"/>
            </a:xfrm>
          </p:grpSpPr>
          <p:sp>
            <p:nvSpPr>
              <p:cNvPr id="51" name="Left Bracket 50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3892883" y="2957273"/>
                <a:ext cx="72743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2009197" y="3534260"/>
              <a:ext cx="270000" cy="111943"/>
              <a:chOff x="3794467" y="2931184"/>
              <a:chExt cx="270000" cy="111943"/>
            </a:xfrm>
          </p:grpSpPr>
          <p:sp>
            <p:nvSpPr>
              <p:cNvPr id="49" name="Left Bracket 48"/>
              <p:cNvSpPr/>
              <p:nvPr/>
            </p:nvSpPr>
            <p:spPr>
              <a:xfrm rot="5400000">
                <a:off x="3911467" y="2883348"/>
                <a:ext cx="36000" cy="270000"/>
              </a:xfrm>
              <a:prstGeom prst="lef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3865478" y="2931184"/>
                <a:ext cx="145486" cy="11194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 anchor="t" anchorCtr="0">
                <a:noAutofit/>
              </a:bodyPr>
              <a:lstStyle/>
              <a:p>
                <a:pPr algn="ctr"/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sp>
          <p:nvSpPr>
            <p:cNvPr id="120" name="TextBox 119"/>
            <p:cNvSpPr txBox="1"/>
            <p:nvPr/>
          </p:nvSpPr>
          <p:spPr>
            <a:xfrm>
              <a:off x="1091181" y="585346"/>
              <a:ext cx="139477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3587" y="1933028"/>
              <a:ext cx="1490663" cy="1476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5452" y="582847"/>
              <a:ext cx="1490663" cy="1476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00" name="Picture 4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1574" y="3284516"/>
              <a:ext cx="1490663" cy="1476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02" name="Picture 6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4713" y="3915504"/>
              <a:ext cx="1563687" cy="1476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Rectangle 4"/>
            <p:cNvSpPr/>
            <p:nvPr/>
          </p:nvSpPr>
          <p:spPr>
            <a:xfrm>
              <a:off x="1025766" y="5922036"/>
              <a:ext cx="4805421" cy="34163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200000"/>
                </a:lnSpc>
                <a:spcAft>
                  <a:spcPts val="0"/>
                </a:spcAft>
              </a:pP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Figure S2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.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 CCR6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IFN</a:t>
              </a:r>
              <a:r>
                <a:rPr lang="en-GB" sz="1200" b="1" dirty="0">
                  <a:latin typeface="Symbol"/>
                  <a:ea typeface="Calibri"/>
                  <a:cs typeface="Times New Roman"/>
                </a:rPr>
                <a:t>g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 CD4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memory T cells secrete GM-CSF, but not Th17 lineage-associated cytokines. 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/>
              </a:r>
              <a:br>
                <a:rPr lang="en-GB" sz="1200" dirty="0">
                  <a:latin typeface="Times New Roman"/>
                  <a:ea typeface="Calibri"/>
                  <a:cs typeface="Times New Roman"/>
                </a:rPr>
              </a:b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PBMC were stimulated with PMA and ionomycin and stained for surface CCR6, intracellular </a:t>
              </a:r>
              <a:r>
                <a:rPr lang="en-GB" sz="1200" dirty="0" err="1">
                  <a:latin typeface="Times New Roman"/>
                  <a:ea typeface="Calibri"/>
                  <a:cs typeface="Times New Roman"/>
                </a:rPr>
                <a:t>IFNγ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and IL-17, and intracellular GM-CSF (n=5), IL-17F (n=3), IL-21 (n=4) or IL-22 (n=4). Data shown are representative examples (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B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) and the mean percentage positive (</a:t>
              </a:r>
              <a:r>
                <a:rPr lang="en-GB" sz="1200" b="1" dirty="0">
                  <a:latin typeface="Times New Roman"/>
                  <a:ea typeface="Calibri"/>
                  <a:cs typeface="Times New Roman"/>
                </a:rPr>
                <a:t>A,C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), gated on CD3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CD4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CD45RO</a:t>
              </a:r>
              <a:r>
                <a:rPr lang="en-GB" sz="1200" baseline="30000" dirty="0">
                  <a:latin typeface="Times New Roman"/>
                  <a:ea typeface="Calibri"/>
                  <a:cs typeface="Times New Roman"/>
                </a:rPr>
                <a:t>+</a:t>
              </a:r>
              <a:r>
                <a:rPr lang="en-GB" sz="1200" dirty="0">
                  <a:latin typeface="Times New Roman"/>
                  <a:ea typeface="Calibri"/>
                  <a:cs typeface="Times New Roman"/>
                </a:rPr>
                <a:t> memory T cells. Repeated measures ANOVA with Bonferroni's multiple comparison test; * = p&lt;0.05, ** = p&lt;0.01, *** = p&lt;0.001. All other comparisons were non-significant (p&gt;0.05).</a:t>
              </a:r>
              <a:endParaRPr lang="en-GB" sz="1200" dirty="0">
                <a:ea typeface="Calibri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22911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1</TotalTime>
  <Words>167</Words>
  <Application>Microsoft Office PowerPoint</Application>
  <PresentationFormat>A4 Paper (210x297 mm)</PresentationFormat>
  <Paragraphs>1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rnow</dc:creator>
  <cp:lastModifiedBy>Curnow</cp:lastModifiedBy>
  <cp:revision>124</cp:revision>
  <cp:lastPrinted>2016-08-04T09:25:51Z</cp:lastPrinted>
  <dcterms:created xsi:type="dcterms:W3CDTF">2016-08-03T08:49:16Z</dcterms:created>
  <dcterms:modified xsi:type="dcterms:W3CDTF">2016-10-19T07:21:37Z</dcterms:modified>
</cp:coreProperties>
</file>